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>
      <p:cViewPr varScale="1">
        <p:scale>
          <a:sx n="80" d="100"/>
          <a:sy n="80" d="100"/>
        </p:scale>
        <p:origin x="52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sychiatry\UserSpace\paulbasil\ngs\ngs_25\core_analys\gnas_plo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psychiatry\UserSpace\paulbasil\ngs\ngs_25\core_analys\gnas_plot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hk_pc_backup\ngs%20ewas%20hk\ngs_25%20analysis\core_analys\gnas_plo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51</c:f>
              <c:strCache>
                <c:ptCount val="1"/>
                <c:pt idx="0">
                  <c:v>Omega-6-SAL-Omega-6-POL</c:v>
                </c:pt>
              </c:strCache>
            </c:strRef>
          </c:tx>
          <c:marker>
            <c:symbol val="none"/>
          </c:marker>
          <c:cat>
            <c:strRef>
              <c:f>Sheet1!$C$50:$L$50</c:f>
              <c:strCache>
                <c:ptCount val="10"/>
                <c:pt idx="0">
                  <c:v>g2041</c:v>
                </c:pt>
                <c:pt idx="1">
                  <c:v>g2066</c:v>
                </c:pt>
                <c:pt idx="2">
                  <c:v>g1528</c:v>
                </c:pt>
                <c:pt idx="3">
                  <c:v>g2075</c:v>
                </c:pt>
                <c:pt idx="4">
                  <c:v>g1536</c:v>
                </c:pt>
                <c:pt idx="5">
                  <c:v>g2063</c:v>
                </c:pt>
                <c:pt idx="6">
                  <c:v>g2072</c:v>
                </c:pt>
                <c:pt idx="7">
                  <c:v>g1534</c:v>
                </c:pt>
                <c:pt idx="8">
                  <c:v>g1255</c:v>
                </c:pt>
                <c:pt idx="9">
                  <c:v>g1257</c:v>
                </c:pt>
              </c:strCache>
            </c:strRef>
          </c:cat>
          <c:val>
            <c:numRef>
              <c:f>Sheet1!$C$51:$L$51</c:f>
              <c:numCache>
                <c:formatCode>General</c:formatCode>
                <c:ptCount val="10"/>
                <c:pt idx="0">
                  <c:v>-15.01683023</c:v>
                </c:pt>
                <c:pt idx="1">
                  <c:v>-16.817814330000001</c:v>
                </c:pt>
                <c:pt idx="2">
                  <c:v>-15.363459880000001</c:v>
                </c:pt>
                <c:pt idx="3">
                  <c:v>-16.051530809999999</c:v>
                </c:pt>
                <c:pt idx="4">
                  <c:v>-14.624676450000001</c:v>
                </c:pt>
                <c:pt idx="5">
                  <c:v>-15.059060329999999</c:v>
                </c:pt>
                <c:pt idx="6">
                  <c:v>-14.826531689999999</c:v>
                </c:pt>
                <c:pt idx="7">
                  <c:v>-13.47605695</c:v>
                </c:pt>
                <c:pt idx="8">
                  <c:v>-4.5892721889999999</c:v>
                </c:pt>
                <c:pt idx="9">
                  <c:v>-3.84906699699999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7E8-44EF-8FE2-A076E76E0201}"/>
            </c:ext>
          </c:extLst>
        </c:ser>
        <c:ser>
          <c:idx val="1"/>
          <c:order val="1"/>
          <c:tx>
            <c:strRef>
              <c:f>Sheet1!$B$52</c:f>
              <c:strCache>
                <c:ptCount val="1"/>
                <c:pt idx="0">
                  <c:v>Omega-3POL-Omega-6-POL</c:v>
                </c:pt>
              </c:strCache>
            </c:strRef>
          </c:tx>
          <c:marker>
            <c:symbol val="none"/>
          </c:marker>
          <c:cat>
            <c:strRef>
              <c:f>Sheet1!$C$50:$L$50</c:f>
              <c:strCache>
                <c:ptCount val="10"/>
                <c:pt idx="0">
                  <c:v>g2041</c:v>
                </c:pt>
                <c:pt idx="1">
                  <c:v>g2066</c:v>
                </c:pt>
                <c:pt idx="2">
                  <c:v>g1528</c:v>
                </c:pt>
                <c:pt idx="3">
                  <c:v>g2075</c:v>
                </c:pt>
                <c:pt idx="4">
                  <c:v>g1536</c:v>
                </c:pt>
                <c:pt idx="5">
                  <c:v>g2063</c:v>
                </c:pt>
                <c:pt idx="6">
                  <c:v>g2072</c:v>
                </c:pt>
                <c:pt idx="7">
                  <c:v>g1534</c:v>
                </c:pt>
                <c:pt idx="8">
                  <c:v>g1255</c:v>
                </c:pt>
                <c:pt idx="9">
                  <c:v>g1257</c:v>
                </c:pt>
              </c:strCache>
            </c:strRef>
          </c:cat>
          <c:val>
            <c:numRef>
              <c:f>Sheet1!$C$52:$L$52</c:f>
              <c:numCache>
                <c:formatCode>General</c:formatCode>
                <c:ptCount val="10"/>
                <c:pt idx="0">
                  <c:v>-11.372968670000001</c:v>
                </c:pt>
                <c:pt idx="1">
                  <c:v>-11.017096779999999</c:v>
                </c:pt>
                <c:pt idx="2">
                  <c:v>-10.65500336</c:v>
                </c:pt>
                <c:pt idx="3">
                  <c:v>-7.3221333869999992</c:v>
                </c:pt>
                <c:pt idx="4">
                  <c:v>-6.0135135139999987</c:v>
                </c:pt>
                <c:pt idx="5">
                  <c:v>-7.330567082</c:v>
                </c:pt>
                <c:pt idx="6">
                  <c:v>-5.4471544719999994</c:v>
                </c:pt>
                <c:pt idx="7">
                  <c:v>4.1353383459999993</c:v>
                </c:pt>
                <c:pt idx="8">
                  <c:v>-3.8701874620000001</c:v>
                </c:pt>
                <c:pt idx="9">
                  <c:v>3.007518796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7E8-44EF-8FE2-A076E76E02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10719896"/>
        <c:axId val="410722640"/>
      </c:lineChart>
      <c:catAx>
        <c:axId val="4107198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10722640"/>
        <c:crosses val="autoZero"/>
        <c:auto val="1"/>
        <c:lblAlgn val="ctr"/>
        <c:lblOffset val="100"/>
        <c:noMultiLvlLbl val="0"/>
      </c:catAx>
      <c:valAx>
        <c:axId val="410722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107198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C$20</c:f>
              <c:strCache>
                <c:ptCount val="1"/>
                <c:pt idx="0">
                  <c:v>Omega-6-SAL-Omega-6-POL</c:v>
                </c:pt>
              </c:strCache>
            </c:strRef>
          </c:tx>
          <c:marker>
            <c:symbol val="none"/>
          </c:marker>
          <c:cat>
            <c:strRef>
              <c:f>Sheet1!$D$19:$G$19</c:f>
              <c:strCache>
                <c:ptCount val="4"/>
                <c:pt idx="0">
                  <c:v>g66</c:v>
                </c:pt>
                <c:pt idx="1">
                  <c:v>g43</c:v>
                </c:pt>
                <c:pt idx="2">
                  <c:v>g56</c:v>
                </c:pt>
                <c:pt idx="3">
                  <c:v>g521</c:v>
                </c:pt>
              </c:strCache>
            </c:strRef>
          </c:cat>
          <c:val>
            <c:numRef>
              <c:f>Sheet1!$D$20:$G$20</c:f>
              <c:numCache>
                <c:formatCode>General</c:formatCode>
                <c:ptCount val="4"/>
                <c:pt idx="0">
                  <c:v>-11.78571429</c:v>
                </c:pt>
                <c:pt idx="1">
                  <c:v>-11.42857143</c:v>
                </c:pt>
                <c:pt idx="2">
                  <c:v>-10.299853730000001</c:v>
                </c:pt>
                <c:pt idx="3">
                  <c:v>-5.19445514099999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9E3-492A-83D3-D6160E70E86E}"/>
            </c:ext>
          </c:extLst>
        </c:ser>
        <c:ser>
          <c:idx val="1"/>
          <c:order val="1"/>
          <c:tx>
            <c:strRef>
              <c:f>Sheet1!$C$21</c:f>
              <c:strCache>
                <c:ptCount val="1"/>
                <c:pt idx="0">
                  <c:v>Omega-3POL-Omega-6-POL</c:v>
                </c:pt>
              </c:strCache>
            </c:strRef>
          </c:tx>
          <c:marker>
            <c:symbol val="none"/>
          </c:marker>
          <c:cat>
            <c:strRef>
              <c:f>Sheet1!$D$19:$G$19</c:f>
              <c:strCache>
                <c:ptCount val="4"/>
                <c:pt idx="0">
                  <c:v>g66</c:v>
                </c:pt>
                <c:pt idx="1">
                  <c:v>g43</c:v>
                </c:pt>
                <c:pt idx="2">
                  <c:v>g56</c:v>
                </c:pt>
                <c:pt idx="3">
                  <c:v>g521</c:v>
                </c:pt>
              </c:strCache>
            </c:strRef>
          </c:cat>
          <c:val>
            <c:numRef>
              <c:f>Sheet1!$D$21:$G$21</c:f>
              <c:numCache>
                <c:formatCode>General</c:formatCode>
                <c:ptCount val="4"/>
                <c:pt idx="0">
                  <c:v>-16.123163250000001</c:v>
                </c:pt>
                <c:pt idx="1">
                  <c:v>-15.73706286</c:v>
                </c:pt>
                <c:pt idx="2">
                  <c:v>-13.835496150000001</c:v>
                </c:pt>
                <c:pt idx="3">
                  <c:v>-8.751608751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9E3-492A-83D3-D6160E70E8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10723816"/>
        <c:axId val="410719504"/>
      </c:lineChart>
      <c:catAx>
        <c:axId val="4107238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10719504"/>
        <c:crosses val="autoZero"/>
        <c:auto val="1"/>
        <c:lblAlgn val="ctr"/>
        <c:lblOffset val="100"/>
        <c:noMultiLvlLbl val="0"/>
      </c:catAx>
      <c:valAx>
        <c:axId val="410719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1072381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52525179191675997"/>
          <c:y val="0.63049108083432803"/>
          <c:w val="0.452035520322355"/>
          <c:h val="0.27931321084864402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34</c:f>
              <c:strCache>
                <c:ptCount val="1"/>
                <c:pt idx="0">
                  <c:v>n-6Pol vs n-6S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Ref>
                <c:f>Sheet1!$R$36:$S$36</c:f>
                <c:numCache>
                  <c:formatCode>General</c:formatCode>
                  <c:ptCount val="2"/>
                  <c:pt idx="0">
                    <c:v>1.4849337944294188</c:v>
                  </c:pt>
                  <c:pt idx="1">
                    <c:v>1.71993948159635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R$33:$S$33</c:f>
              <c:strCache>
                <c:ptCount val="2"/>
                <c:pt idx="0">
                  <c:v>Gnas6</c:v>
                </c:pt>
                <c:pt idx="1">
                  <c:v>Gnas9</c:v>
                </c:pt>
              </c:strCache>
            </c:strRef>
          </c:cat>
          <c:val>
            <c:numRef>
              <c:f>Sheet1!$R$34:$S$34</c:f>
              <c:numCache>
                <c:formatCode>General</c:formatCode>
                <c:ptCount val="2"/>
                <c:pt idx="0">
                  <c:v>-12.967429985600001</c:v>
                </c:pt>
                <c:pt idx="1">
                  <c:v>-9.67714864775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63-46BD-8C31-1ADCDA433DFB}"/>
            </c:ext>
          </c:extLst>
        </c:ser>
        <c:ser>
          <c:idx val="1"/>
          <c:order val="1"/>
          <c:tx>
            <c:strRef>
              <c:f>Sheet1!$Q$35</c:f>
              <c:strCache>
                <c:ptCount val="1"/>
                <c:pt idx="0">
                  <c:v>n-3Pol vs n-6Po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Ref>
                <c:f>Sheet1!$R$37:$S$37</c:f>
                <c:numCache>
                  <c:formatCode>General</c:formatCode>
                  <c:ptCount val="2"/>
                  <c:pt idx="0">
                    <c:v>1.5274115774947523</c:v>
                  </c:pt>
                  <c:pt idx="1">
                    <c:v>1.69546420703190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R$33:$S$33</c:f>
              <c:strCache>
                <c:ptCount val="2"/>
                <c:pt idx="0">
                  <c:v>Gnas6</c:v>
                </c:pt>
                <c:pt idx="1">
                  <c:v>Gnas9</c:v>
                </c:pt>
              </c:strCache>
            </c:strRef>
          </c:cat>
          <c:val>
            <c:numRef>
              <c:f>Sheet1!$R$35:$S$35</c:f>
              <c:numCache>
                <c:formatCode>General</c:formatCode>
                <c:ptCount val="2"/>
                <c:pt idx="0">
                  <c:v>-5.5885767584000003</c:v>
                </c:pt>
                <c:pt idx="1">
                  <c:v>-13.611832752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63-46BD-8C31-1ADCDA433D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2326976"/>
        <c:axId val="332327304"/>
      </c:barChart>
      <c:catAx>
        <c:axId val="3323269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32327304"/>
        <c:crosses val="autoZero"/>
        <c:auto val="1"/>
        <c:lblAlgn val="ctr"/>
        <c:lblOffset val="100"/>
        <c:noMultiLvlLbl val="0"/>
      </c:catAx>
      <c:valAx>
        <c:axId val="3323273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2326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364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3983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8256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0903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3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373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9469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2369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9129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5761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01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53157-6D6E-4B58-BE77-CA20E89A3F32}" type="datetimeFigureOut">
              <a:rPr lang="en-GB" smtClean="0"/>
              <a:t>10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3D7CC-41B9-4D44-8418-409C2F9FB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1094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P:\ngs\ngs_25\core_analys\gnas_epimap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180" y="619553"/>
            <a:ext cx="8157160" cy="2017163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" name="Straight Arrow Connector 5"/>
          <p:cNvCxnSpPr/>
          <p:nvPr/>
        </p:nvCxnSpPr>
        <p:spPr>
          <a:xfrm flipH="1">
            <a:off x="9605702" y="2013986"/>
            <a:ext cx="431795" cy="286629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H="1" flipV="1">
            <a:off x="9605702" y="2551840"/>
            <a:ext cx="431795" cy="336522"/>
          </a:xfrm>
          <a:prstGeom prst="straightConnector1">
            <a:avLst/>
          </a:prstGeom>
          <a:ln w="3810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9913141" y="1719798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s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951139" y="2685070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s9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450112" y="619553"/>
            <a:ext cx="360074" cy="433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5834269"/>
              </p:ext>
            </p:extLst>
          </p:nvPr>
        </p:nvGraphicFramePr>
        <p:xfrm>
          <a:off x="747896" y="2810694"/>
          <a:ext cx="3357695" cy="3744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1166754" y="2938452"/>
            <a:ext cx="416105" cy="469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3971499"/>
              </p:ext>
            </p:extLst>
          </p:nvPr>
        </p:nvGraphicFramePr>
        <p:xfrm>
          <a:off x="3925190" y="3159512"/>
          <a:ext cx="3714854" cy="33679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3805237" y="2969671"/>
            <a:ext cx="366682" cy="4415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E925D3F0-D0D1-459E-BD4F-A129C37375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8874727"/>
              </p:ext>
            </p:extLst>
          </p:nvPr>
        </p:nvGraphicFramePr>
        <p:xfrm>
          <a:off x="7521904" y="373145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4404645A-8938-4D2D-B61B-7B98BED1CA46}"/>
              </a:ext>
            </a:extLst>
          </p:cNvPr>
          <p:cNvSpPr txBox="1"/>
          <p:nvPr/>
        </p:nvSpPr>
        <p:spPr>
          <a:xfrm>
            <a:off x="7627274" y="308597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DCFD56-B285-476B-8866-7B0CFA924BE7}"/>
              </a:ext>
            </a:extLst>
          </p:cNvPr>
          <p:cNvSpPr txBox="1"/>
          <p:nvPr/>
        </p:nvSpPr>
        <p:spPr>
          <a:xfrm>
            <a:off x="8566484" y="3455307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Gnas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B92F8D0-A4BC-4F93-8F71-E8AD5464288A}"/>
              </a:ext>
            </a:extLst>
          </p:cNvPr>
          <p:cNvSpPr txBox="1"/>
          <p:nvPr/>
        </p:nvSpPr>
        <p:spPr>
          <a:xfrm>
            <a:off x="10583776" y="3463323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Gnas9</a:t>
            </a:r>
          </a:p>
        </p:txBody>
      </p:sp>
    </p:spTree>
    <p:extLst>
      <p:ext uri="{BB962C8B-B14F-4D97-AF65-F5344CB8AC3E}">
        <p14:creationId xmlns:p14="http://schemas.microsoft.com/office/powerpoint/2010/main" val="1428592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8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zil</dc:creator>
  <cp:lastModifiedBy>bazil</cp:lastModifiedBy>
  <cp:revision>11</cp:revision>
  <dcterms:created xsi:type="dcterms:W3CDTF">2015-11-22T22:06:49Z</dcterms:created>
  <dcterms:modified xsi:type="dcterms:W3CDTF">2017-09-10T05:11:34Z</dcterms:modified>
</cp:coreProperties>
</file>